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rels" ContentType="application/vnd.openxmlformats-package.relationships+xml"/>
  <Default Extension="wdp" ContentType="image/vnd.ms-photo"/>
  <Default Extension="tif" ContentType="image/tiff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5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9B400"/>
    <a:srgbClr val="A6A6A6"/>
    <a:srgbClr val="7F7F7F"/>
    <a:srgbClr val="555555"/>
    <a:srgbClr val="05E800"/>
    <a:srgbClr val="1A65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854" autoAdjust="0"/>
    <p:restoredTop sz="97717" autoAdjust="0"/>
  </p:normalViewPr>
  <p:slideViewPr>
    <p:cSldViewPr snapToGrid="0" snapToObjects="1">
      <p:cViewPr>
        <p:scale>
          <a:sx n="200" d="100"/>
          <a:sy n="200" d="100"/>
        </p:scale>
        <p:origin x="-80" y="20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70F67-5473-AF48-B05D-127E3B9C509F}" type="datetimeFigureOut">
              <a:rPr lang="fr-FR" smtClean="0"/>
              <a:t>13/10/17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7C9A88-05E9-8845-93C0-D199129BB6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252909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7B5A8-BF67-704C-AD71-2B0235AC2383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AF027-CC21-5144-BC0B-1EBF557219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23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03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419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012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712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29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699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448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43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193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230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839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407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6" Type="http://schemas.openxmlformats.org/officeDocument/2006/relationships/image" Target="../media/image3.jpg"/><Relationship Id="rId7" Type="http://schemas.openxmlformats.org/officeDocument/2006/relationships/image" Target="../media/image4.jpg"/><Relationship Id="rId8" Type="http://schemas.openxmlformats.org/officeDocument/2006/relationships/image" Target="../media/image5.jpg"/><Relationship Id="rId9" Type="http://schemas.openxmlformats.org/officeDocument/2006/relationships/image" Target="../media/image6.tif"/><Relationship Id="rId10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8" name="Grouper 147"/>
          <p:cNvGrpSpPr>
            <a:grpSpLocks noChangeAspect="1"/>
          </p:cNvGrpSpPr>
          <p:nvPr/>
        </p:nvGrpSpPr>
        <p:grpSpPr>
          <a:xfrm>
            <a:off x="2147432" y="1717152"/>
            <a:ext cx="1737226" cy="964092"/>
            <a:chOff x="515471" y="140983"/>
            <a:chExt cx="4227152" cy="1926128"/>
          </a:xfrm>
        </p:grpSpPr>
        <p:grpSp>
          <p:nvGrpSpPr>
            <p:cNvPr id="149" name="Grouper 148"/>
            <p:cNvGrpSpPr/>
            <p:nvPr/>
          </p:nvGrpSpPr>
          <p:grpSpPr>
            <a:xfrm>
              <a:off x="615009" y="159111"/>
              <a:ext cx="1968338" cy="1908000"/>
              <a:chOff x="623476" y="159111"/>
              <a:chExt cx="1968338" cy="1908000"/>
            </a:xfrm>
          </p:grpSpPr>
          <p:grpSp>
            <p:nvGrpSpPr>
              <p:cNvPr id="168" name="Grouper 167"/>
              <p:cNvGrpSpPr/>
              <p:nvPr/>
            </p:nvGrpSpPr>
            <p:grpSpPr>
              <a:xfrm>
                <a:off x="623476" y="159111"/>
                <a:ext cx="1968338" cy="1908000"/>
                <a:chOff x="623476" y="159111"/>
                <a:chExt cx="1968338" cy="1908000"/>
              </a:xfrm>
            </p:grpSpPr>
            <p:grpSp>
              <p:nvGrpSpPr>
                <p:cNvPr id="171" name="Grouper 170"/>
                <p:cNvGrpSpPr/>
                <p:nvPr/>
              </p:nvGrpSpPr>
              <p:grpSpPr>
                <a:xfrm>
                  <a:off x="623476" y="159111"/>
                  <a:ext cx="1908000" cy="1908000"/>
                  <a:chOff x="3793111" y="168288"/>
                  <a:chExt cx="1908000" cy="1908000"/>
                </a:xfrm>
              </p:grpSpPr>
              <p:pic>
                <p:nvPicPr>
                  <p:cNvPr id="174" name="Image 173" descr="lgg1 gfp daf-18 e1375 J8 X100 3.tif"/>
                  <p:cNvPicPr>
                    <a:picLocks/>
                  </p:cNvPicPr>
                  <p:nvPr/>
                </p:nvPicPr>
                <p:blipFill rotWithShape="1">
                  <a:blip r:embed="rId2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sharpenSoften amount="-25000"/>
                            </a14:imgEffect>
                            <a14:imgEffect>
                              <a14:brightnessContrast contras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23477"/>
                  <a:stretch/>
                </p:blipFill>
                <p:spPr>
                  <a:xfrm rot="5400000">
                    <a:off x="3793111" y="168288"/>
                    <a:ext cx="1908000" cy="1908000"/>
                  </a:xfrm>
                  <a:prstGeom prst="rect">
                    <a:avLst/>
                  </a:prstGeom>
                </p:spPr>
              </p:pic>
              <p:cxnSp>
                <p:nvCxnSpPr>
                  <p:cNvPr id="175" name="Connecteur droit avec flèche 174"/>
                  <p:cNvCxnSpPr/>
                  <p:nvPr/>
                </p:nvCxnSpPr>
                <p:spPr>
                  <a:xfrm rot="16200000" flipH="1">
                    <a:off x="4335135" y="1368916"/>
                    <a:ext cx="47400" cy="143927"/>
                  </a:xfrm>
                  <a:prstGeom prst="straightConnector1">
                    <a:avLst/>
                  </a:prstGeom>
                  <a:ln>
                    <a:solidFill>
                      <a:schemeClr val="bg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72" name="ZoneTexte 171"/>
                <p:cNvSpPr txBox="1"/>
                <p:nvPr/>
              </p:nvSpPr>
              <p:spPr>
                <a:xfrm>
                  <a:off x="1369678" y="1749426"/>
                  <a:ext cx="1222136" cy="2303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 defTabSz="881390">
                    <a:defRPr/>
                  </a:pPr>
                  <a:endParaRPr lang="fr-FR" sz="600" kern="0" dirty="0">
                    <a:solidFill>
                      <a:sysClr val="window" lastClr="FFFFFF"/>
                    </a:solidFill>
                    <a:latin typeface="Calibri"/>
                    <a:cs typeface="Calibri"/>
                  </a:endParaRPr>
                </a:p>
              </p:txBody>
            </p:sp>
            <p:sp>
              <p:nvSpPr>
                <p:cNvPr id="173" name="ZoneTexte 172"/>
                <p:cNvSpPr txBox="1"/>
                <p:nvPr/>
              </p:nvSpPr>
              <p:spPr>
                <a:xfrm>
                  <a:off x="654098" y="185849"/>
                  <a:ext cx="699460" cy="26875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881390">
                    <a:defRPr/>
                  </a:pPr>
                  <a:r>
                    <a:rPr lang="fr-FR" sz="800" kern="0" dirty="0" smtClean="0">
                      <a:solidFill>
                        <a:schemeClr val="bg1"/>
                      </a:solidFill>
                      <a:latin typeface="Arial" charset="0"/>
                      <a:ea typeface="Arial" charset="0"/>
                      <a:cs typeface="Arial" charset="0"/>
                    </a:rPr>
                    <a:t>Day 1</a:t>
                  </a:r>
                  <a:endParaRPr lang="fr-FR" sz="800" kern="0" dirty="0">
                    <a:solidFill>
                      <a:schemeClr val="bg1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69" name="Forme libre 168"/>
              <p:cNvSpPr/>
              <p:nvPr/>
            </p:nvSpPr>
            <p:spPr>
              <a:xfrm>
                <a:off x="846667" y="160867"/>
                <a:ext cx="1270000" cy="1879600"/>
              </a:xfrm>
              <a:custGeom>
                <a:avLst/>
                <a:gdLst>
                  <a:gd name="connsiteX0" fmla="*/ 0 w 1270000"/>
                  <a:gd name="connsiteY0" fmla="*/ 1879600 h 1879600"/>
                  <a:gd name="connsiteX1" fmla="*/ 270933 w 1270000"/>
                  <a:gd name="connsiteY1" fmla="*/ 973666 h 1879600"/>
                  <a:gd name="connsiteX2" fmla="*/ 643466 w 1270000"/>
                  <a:gd name="connsiteY2" fmla="*/ 558800 h 1879600"/>
                  <a:gd name="connsiteX3" fmla="*/ 1270000 w 1270000"/>
                  <a:gd name="connsiteY3" fmla="*/ 0 h 18796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270000" h="1879600">
                    <a:moveTo>
                      <a:pt x="0" y="1879600"/>
                    </a:moveTo>
                    <a:cubicBezTo>
                      <a:pt x="81844" y="1536699"/>
                      <a:pt x="163689" y="1193799"/>
                      <a:pt x="270933" y="973666"/>
                    </a:cubicBezTo>
                    <a:cubicBezTo>
                      <a:pt x="378177" y="753533"/>
                      <a:pt x="476955" y="721078"/>
                      <a:pt x="643466" y="558800"/>
                    </a:cubicBezTo>
                    <a:cubicBezTo>
                      <a:pt x="809977" y="396522"/>
                      <a:pt x="1270000" y="0"/>
                      <a:pt x="1270000" y="0"/>
                    </a:cubicBezTo>
                  </a:path>
                </a:pathLst>
              </a:custGeom>
              <a:ln w="6350" cmpd="sng"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70" name="Forme libre 169"/>
              <p:cNvSpPr/>
              <p:nvPr/>
            </p:nvSpPr>
            <p:spPr>
              <a:xfrm>
                <a:off x="1075267" y="169333"/>
                <a:ext cx="1236133" cy="1871134"/>
              </a:xfrm>
              <a:custGeom>
                <a:avLst/>
                <a:gdLst>
                  <a:gd name="connsiteX0" fmla="*/ 0 w 1236133"/>
                  <a:gd name="connsiteY0" fmla="*/ 1871134 h 1871134"/>
                  <a:gd name="connsiteX1" fmla="*/ 440266 w 1236133"/>
                  <a:gd name="connsiteY1" fmla="*/ 1295400 h 1871134"/>
                  <a:gd name="connsiteX2" fmla="*/ 778933 w 1236133"/>
                  <a:gd name="connsiteY2" fmla="*/ 736600 h 1871134"/>
                  <a:gd name="connsiteX3" fmla="*/ 1236133 w 1236133"/>
                  <a:gd name="connsiteY3" fmla="*/ 0 h 187113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236133" h="1871134">
                    <a:moveTo>
                      <a:pt x="0" y="1871134"/>
                    </a:moveTo>
                    <a:cubicBezTo>
                      <a:pt x="155222" y="1677811"/>
                      <a:pt x="310444" y="1484489"/>
                      <a:pt x="440266" y="1295400"/>
                    </a:cubicBezTo>
                    <a:cubicBezTo>
                      <a:pt x="570088" y="1106311"/>
                      <a:pt x="646289" y="952500"/>
                      <a:pt x="778933" y="736600"/>
                    </a:cubicBezTo>
                    <a:cubicBezTo>
                      <a:pt x="911578" y="520700"/>
                      <a:pt x="1236133" y="0"/>
                      <a:pt x="1236133" y="0"/>
                    </a:cubicBezTo>
                  </a:path>
                </a:pathLst>
              </a:custGeom>
              <a:ln w="6350" cmpd="sng"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150" name="Grouper 149"/>
            <p:cNvGrpSpPr/>
            <p:nvPr/>
          </p:nvGrpSpPr>
          <p:grpSpPr>
            <a:xfrm>
              <a:off x="1282867" y="142243"/>
              <a:ext cx="3391443" cy="1903102"/>
              <a:chOff x="2952437" y="147717"/>
              <a:chExt cx="3391443" cy="1903102"/>
            </a:xfrm>
          </p:grpSpPr>
          <p:grpSp>
            <p:nvGrpSpPr>
              <p:cNvPr id="154" name="Grouper 153"/>
              <p:cNvGrpSpPr/>
              <p:nvPr/>
            </p:nvGrpSpPr>
            <p:grpSpPr>
              <a:xfrm rot="16200000">
                <a:off x="4312999" y="19937"/>
                <a:ext cx="1903102" cy="2158661"/>
                <a:chOff x="6073060" y="4199764"/>
                <a:chExt cx="2891085" cy="2159998"/>
              </a:xfrm>
            </p:grpSpPr>
            <p:grpSp>
              <p:nvGrpSpPr>
                <p:cNvPr id="158" name="Grouper 157"/>
                <p:cNvGrpSpPr/>
                <p:nvPr/>
              </p:nvGrpSpPr>
              <p:grpSpPr>
                <a:xfrm>
                  <a:off x="6073060" y="4199764"/>
                  <a:ext cx="2891085" cy="2159998"/>
                  <a:chOff x="6252915" y="2523364"/>
                  <a:chExt cx="2891085" cy="2159998"/>
                </a:xfrm>
              </p:grpSpPr>
              <p:pic>
                <p:nvPicPr>
                  <p:cNvPr id="165" name="Image 164" descr="lgg1 gfp daf-18 e1375 J8 X100 8.tif"/>
                  <p:cNvPicPr>
                    <a:picLocks noChangeAspect="1"/>
                  </p:cNvPicPr>
                  <p:nvPr/>
                </p:nvPicPr>
                <p:blipFill>
                  <a:blip r:embed="rId4">
                    <a:alphaModFix/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brightnessContrast bright="20000" contrast="8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252915" y="2523364"/>
                    <a:ext cx="2891071" cy="2159998"/>
                  </a:xfrm>
                  <a:prstGeom prst="rect">
                    <a:avLst/>
                  </a:prstGeom>
                </p:spPr>
              </p:pic>
              <p:sp>
                <p:nvSpPr>
                  <p:cNvPr id="166" name="Forme libre 165"/>
                  <p:cNvSpPr/>
                  <p:nvPr/>
                </p:nvSpPr>
                <p:spPr>
                  <a:xfrm>
                    <a:off x="6394323" y="2550753"/>
                    <a:ext cx="2749677" cy="1911180"/>
                  </a:xfrm>
                  <a:custGeom>
                    <a:avLst/>
                    <a:gdLst>
                      <a:gd name="connsiteX0" fmla="*/ 0 w 2295525"/>
                      <a:gd name="connsiteY0" fmla="*/ 0 h 1552575"/>
                      <a:gd name="connsiteX1" fmla="*/ 638175 w 2295525"/>
                      <a:gd name="connsiteY1" fmla="*/ 352425 h 1552575"/>
                      <a:gd name="connsiteX2" fmla="*/ 1304925 w 2295525"/>
                      <a:gd name="connsiteY2" fmla="*/ 723900 h 1552575"/>
                      <a:gd name="connsiteX3" fmla="*/ 1624013 w 2295525"/>
                      <a:gd name="connsiteY3" fmla="*/ 976312 h 1552575"/>
                      <a:gd name="connsiteX4" fmla="*/ 2295525 w 2295525"/>
                      <a:gd name="connsiteY4" fmla="*/ 1552575 h 155257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2295525" h="1552575">
                        <a:moveTo>
                          <a:pt x="0" y="0"/>
                        </a:moveTo>
                        <a:lnTo>
                          <a:pt x="638175" y="352425"/>
                        </a:lnTo>
                        <a:cubicBezTo>
                          <a:pt x="855662" y="473075"/>
                          <a:pt x="1140619" y="619919"/>
                          <a:pt x="1304925" y="723900"/>
                        </a:cubicBezTo>
                        <a:cubicBezTo>
                          <a:pt x="1469231" y="827881"/>
                          <a:pt x="1458913" y="838200"/>
                          <a:pt x="1624013" y="976312"/>
                        </a:cubicBezTo>
                        <a:cubicBezTo>
                          <a:pt x="1789113" y="1114424"/>
                          <a:pt x="2042319" y="1333499"/>
                          <a:pt x="2295525" y="1552575"/>
                        </a:cubicBezTo>
                      </a:path>
                    </a:pathLst>
                  </a:custGeom>
                  <a:noFill/>
                  <a:ln w="6350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67" name="Forme libre 166"/>
                  <p:cNvSpPr/>
                  <p:nvPr/>
                </p:nvSpPr>
                <p:spPr>
                  <a:xfrm>
                    <a:off x="6252922" y="2718726"/>
                    <a:ext cx="2891077" cy="1844805"/>
                  </a:xfrm>
                  <a:custGeom>
                    <a:avLst/>
                    <a:gdLst>
                      <a:gd name="connsiteX0" fmla="*/ 0 w 2366962"/>
                      <a:gd name="connsiteY0" fmla="*/ 0 h 1538288"/>
                      <a:gd name="connsiteX1" fmla="*/ 742950 w 2366962"/>
                      <a:gd name="connsiteY1" fmla="*/ 566738 h 1538288"/>
                      <a:gd name="connsiteX2" fmla="*/ 1395412 w 2366962"/>
                      <a:gd name="connsiteY2" fmla="*/ 1004888 h 1538288"/>
                      <a:gd name="connsiteX3" fmla="*/ 2366962 w 2366962"/>
                      <a:gd name="connsiteY3" fmla="*/ 1538288 h 153828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2366962" h="1538288">
                        <a:moveTo>
                          <a:pt x="0" y="0"/>
                        </a:moveTo>
                        <a:cubicBezTo>
                          <a:pt x="255190" y="199628"/>
                          <a:pt x="510381" y="399257"/>
                          <a:pt x="742950" y="566738"/>
                        </a:cubicBezTo>
                        <a:cubicBezTo>
                          <a:pt x="975519" y="734219"/>
                          <a:pt x="1124743" y="842963"/>
                          <a:pt x="1395412" y="1004888"/>
                        </a:cubicBezTo>
                        <a:cubicBezTo>
                          <a:pt x="1666081" y="1166813"/>
                          <a:pt x="2016521" y="1352550"/>
                          <a:pt x="2366962" y="1538288"/>
                        </a:cubicBezTo>
                      </a:path>
                    </a:pathLst>
                  </a:custGeom>
                  <a:noFill/>
                  <a:ln w="6350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</p:grpSp>
            <p:cxnSp>
              <p:nvCxnSpPr>
                <p:cNvPr id="159" name="Connecteur droit avec flèche 158"/>
                <p:cNvCxnSpPr/>
                <p:nvPr/>
              </p:nvCxnSpPr>
              <p:spPr>
                <a:xfrm flipH="1">
                  <a:off x="6751674" y="4617599"/>
                  <a:ext cx="72007" cy="14401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0" name="Connecteur droit avec flèche 159"/>
                <p:cNvCxnSpPr/>
                <p:nvPr/>
              </p:nvCxnSpPr>
              <p:spPr>
                <a:xfrm flipH="1">
                  <a:off x="6955327" y="4584734"/>
                  <a:ext cx="72007" cy="14401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1" name="Connecteur droit avec flèche 160"/>
                <p:cNvCxnSpPr/>
                <p:nvPr/>
              </p:nvCxnSpPr>
              <p:spPr>
                <a:xfrm flipH="1">
                  <a:off x="7129194" y="4796901"/>
                  <a:ext cx="72007" cy="14401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2" name="Connecteur droit avec flèche 161"/>
                <p:cNvCxnSpPr/>
                <p:nvPr/>
              </p:nvCxnSpPr>
              <p:spPr>
                <a:xfrm flipH="1">
                  <a:off x="7456960" y="5027290"/>
                  <a:ext cx="72007" cy="14401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3" name="Connecteur droit avec flèche 162"/>
                <p:cNvCxnSpPr/>
                <p:nvPr/>
              </p:nvCxnSpPr>
              <p:spPr>
                <a:xfrm flipH="1">
                  <a:off x="7744536" y="5054391"/>
                  <a:ext cx="72007" cy="14401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4" name="Connecteur droit avec flèche 163"/>
                <p:cNvCxnSpPr/>
                <p:nvPr/>
              </p:nvCxnSpPr>
              <p:spPr>
                <a:xfrm flipH="1">
                  <a:off x="8453474" y="5582557"/>
                  <a:ext cx="72007" cy="14401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5" name="ZoneTexte 154"/>
              <p:cNvSpPr txBox="1"/>
              <p:nvPr/>
            </p:nvSpPr>
            <p:spPr>
              <a:xfrm>
                <a:off x="4191062" y="189622"/>
                <a:ext cx="787137" cy="2687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881390">
                  <a:defRPr/>
                </a:pPr>
                <a:r>
                  <a:rPr lang="fr-FR" sz="800" kern="0" dirty="0">
                    <a:solidFill>
                      <a:srgbClr val="FFFFFF"/>
                    </a:solidFill>
                    <a:latin typeface="Arial" charset="0"/>
                    <a:ea typeface="Arial" charset="0"/>
                    <a:cs typeface="Arial" charset="0"/>
                  </a:rPr>
                  <a:t>D</a:t>
                </a:r>
                <a:r>
                  <a:rPr lang="fr-FR" sz="800" kern="0" dirty="0" smtClean="0">
                    <a:solidFill>
                      <a:srgbClr val="FFFFFF"/>
                    </a:solidFill>
                    <a:latin typeface="Arial" charset="0"/>
                    <a:ea typeface="Arial" charset="0"/>
                    <a:cs typeface="Arial" charset="0"/>
                  </a:rPr>
                  <a:t>ay 12</a:t>
                </a:r>
                <a:endParaRPr lang="fr-FR" sz="800" kern="0" dirty="0">
                  <a:solidFill>
                    <a:srgbClr val="FFFFFF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56" name="Connecteur droit 155"/>
              <p:cNvCxnSpPr/>
              <p:nvPr/>
            </p:nvCxnSpPr>
            <p:spPr>
              <a:xfrm flipV="1">
                <a:off x="5977966" y="1932034"/>
                <a:ext cx="290823" cy="1887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" lastClr="FFFFFF"/>
                </a:solidFill>
                <a:prstDash val="solid"/>
              </a:ln>
              <a:effectLst/>
            </p:spPr>
          </p:cxnSp>
          <p:sp>
            <p:nvSpPr>
              <p:cNvPr id="157" name="ZoneTexte 156"/>
              <p:cNvSpPr txBox="1"/>
              <p:nvPr/>
            </p:nvSpPr>
            <p:spPr>
              <a:xfrm>
                <a:off x="2952437" y="1750696"/>
                <a:ext cx="1222136" cy="230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881390">
                  <a:defRPr/>
                </a:pPr>
                <a:endParaRPr lang="fr-FR" sz="600" kern="0" dirty="0">
                  <a:solidFill>
                    <a:sysClr val="window" lastClr="FFFFFF"/>
                  </a:solidFill>
                  <a:latin typeface="Calibri"/>
                  <a:cs typeface="Calibri"/>
                </a:endParaRPr>
              </a:p>
            </p:txBody>
          </p:sp>
        </p:grpSp>
        <p:cxnSp>
          <p:nvCxnSpPr>
            <p:cNvPr id="151" name="Connecteur droit 150"/>
            <p:cNvCxnSpPr/>
            <p:nvPr/>
          </p:nvCxnSpPr>
          <p:spPr>
            <a:xfrm flipV="1">
              <a:off x="515471" y="140983"/>
              <a:ext cx="4176828" cy="11863"/>
            </a:xfrm>
            <a:prstGeom prst="line">
              <a:avLst/>
            </a:prstGeom>
            <a:noFill/>
            <a:ln w="38100" cap="flat" cmpd="sng" algn="ctr">
              <a:solidFill>
                <a:schemeClr val="bg1"/>
              </a:solidFill>
              <a:prstDash val="solid"/>
            </a:ln>
            <a:effectLst/>
          </p:spPr>
        </p:cxnSp>
        <p:cxnSp>
          <p:nvCxnSpPr>
            <p:cNvPr id="152" name="Connecteur droit 151"/>
            <p:cNvCxnSpPr/>
            <p:nvPr/>
          </p:nvCxnSpPr>
          <p:spPr>
            <a:xfrm flipV="1">
              <a:off x="515471" y="2051520"/>
              <a:ext cx="4227152" cy="4488"/>
            </a:xfrm>
            <a:prstGeom prst="line">
              <a:avLst/>
            </a:prstGeom>
            <a:noFill/>
            <a:ln w="57150" cap="flat" cmpd="sng" algn="ctr">
              <a:solidFill>
                <a:schemeClr val="bg1"/>
              </a:solidFill>
              <a:prstDash val="solid"/>
            </a:ln>
            <a:effectLst/>
          </p:spPr>
        </p:cxnSp>
        <p:cxnSp>
          <p:nvCxnSpPr>
            <p:cNvPr id="153" name="Connecteur droit 152"/>
            <p:cNvCxnSpPr/>
            <p:nvPr/>
          </p:nvCxnSpPr>
          <p:spPr>
            <a:xfrm>
              <a:off x="2528068" y="161175"/>
              <a:ext cx="5099" cy="1902699"/>
            </a:xfrm>
            <a:prstGeom prst="line">
              <a:avLst/>
            </a:prstGeom>
            <a:noFill/>
            <a:ln w="28575" cap="flat" cmpd="sng" algn="ctr">
              <a:solidFill>
                <a:sysClr val="window" lastClr="FFFFFF"/>
              </a:solidFill>
              <a:prstDash val="solid"/>
            </a:ln>
            <a:effectLst/>
          </p:spPr>
        </p:cxnSp>
      </p:grpSp>
      <p:grpSp>
        <p:nvGrpSpPr>
          <p:cNvPr id="176" name="Grouper 175"/>
          <p:cNvGrpSpPr>
            <a:grpSpLocks noChangeAspect="1"/>
          </p:cNvGrpSpPr>
          <p:nvPr/>
        </p:nvGrpSpPr>
        <p:grpSpPr>
          <a:xfrm>
            <a:off x="218050" y="1738758"/>
            <a:ext cx="1955545" cy="918690"/>
            <a:chOff x="150521" y="606745"/>
            <a:chExt cx="2591838" cy="1563385"/>
          </a:xfrm>
        </p:grpSpPr>
        <p:grpSp>
          <p:nvGrpSpPr>
            <p:cNvPr id="177" name="Grouper 176"/>
            <p:cNvGrpSpPr/>
            <p:nvPr/>
          </p:nvGrpSpPr>
          <p:grpSpPr>
            <a:xfrm>
              <a:off x="150521" y="1843192"/>
              <a:ext cx="562799" cy="184666"/>
              <a:chOff x="-45433" y="1581332"/>
              <a:chExt cx="832653" cy="185678"/>
            </a:xfrm>
          </p:grpSpPr>
          <p:sp>
            <p:nvSpPr>
              <p:cNvPr id="188" name="ZoneTexte 187"/>
              <p:cNvSpPr txBox="1"/>
              <p:nvPr/>
            </p:nvSpPr>
            <p:spPr>
              <a:xfrm>
                <a:off x="-45433" y="1581332"/>
                <a:ext cx="832653" cy="1856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881390">
                  <a:defRPr/>
                </a:pPr>
                <a:endParaRPr lang="fr-FR" sz="600" kern="0" dirty="0">
                  <a:solidFill>
                    <a:sysClr val="window" lastClr="FFFFFF"/>
                  </a:solidFill>
                  <a:latin typeface="Calibri"/>
                  <a:cs typeface="Calibri"/>
                </a:endParaRPr>
              </a:p>
            </p:txBody>
          </p:sp>
          <p:cxnSp>
            <p:nvCxnSpPr>
              <p:cNvPr id="189" name="Connecteur droit 188"/>
              <p:cNvCxnSpPr/>
              <p:nvPr/>
            </p:nvCxnSpPr>
            <p:spPr>
              <a:xfrm flipV="1">
                <a:off x="517366" y="1766065"/>
                <a:ext cx="179997" cy="945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" lastClr="FFFFFF"/>
                </a:solidFill>
                <a:prstDash val="solid"/>
              </a:ln>
              <a:effectLst/>
            </p:spPr>
          </p:cxnSp>
        </p:grpSp>
        <p:grpSp>
          <p:nvGrpSpPr>
            <p:cNvPr id="178" name="Grouper 177"/>
            <p:cNvGrpSpPr/>
            <p:nvPr/>
          </p:nvGrpSpPr>
          <p:grpSpPr>
            <a:xfrm>
              <a:off x="499283" y="1127694"/>
              <a:ext cx="2243076" cy="500787"/>
              <a:chOff x="4544254" y="1531106"/>
              <a:chExt cx="2243076" cy="500787"/>
            </a:xfrm>
          </p:grpSpPr>
          <p:pic>
            <p:nvPicPr>
              <p:cNvPr id="186" name="Image 185" descr="CROPtrait discontinu crop.jpg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086" b="8144"/>
              <a:stretch/>
            </p:blipFill>
            <p:spPr>
              <a:xfrm rot="10800000" flipV="1">
                <a:off x="4544254" y="1531106"/>
                <a:ext cx="2243076" cy="500787"/>
              </a:xfrm>
              <a:prstGeom prst="rect">
                <a:avLst/>
              </a:prstGeom>
            </p:spPr>
          </p:pic>
          <p:sp>
            <p:nvSpPr>
              <p:cNvPr id="187" name="ZoneTexte 186"/>
              <p:cNvSpPr txBox="1"/>
              <p:nvPr/>
            </p:nvSpPr>
            <p:spPr>
              <a:xfrm>
                <a:off x="4546154" y="1544235"/>
                <a:ext cx="12103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881390">
                  <a:defRPr/>
                </a:pPr>
                <a:r>
                  <a:rPr lang="fr-FR" sz="800" kern="0" dirty="0" err="1" smtClean="0">
                    <a:solidFill>
                      <a:srgbClr val="FFFFFF"/>
                    </a:solidFill>
                    <a:latin typeface="Arial" charset="0"/>
                    <a:ea typeface="Arial" charset="0"/>
                    <a:cs typeface="Arial" charset="0"/>
                  </a:rPr>
                  <a:t>Intermediate</a:t>
                </a:r>
                <a:endParaRPr lang="fr-FR" sz="800" kern="0">
                  <a:solidFill>
                    <a:srgbClr val="FFFFFF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79" name="Grouper 178"/>
            <p:cNvGrpSpPr/>
            <p:nvPr/>
          </p:nvGrpSpPr>
          <p:grpSpPr>
            <a:xfrm>
              <a:off x="500624" y="1643155"/>
              <a:ext cx="2238379" cy="526975"/>
              <a:chOff x="4543983" y="2423565"/>
              <a:chExt cx="2238379" cy="526975"/>
            </a:xfrm>
          </p:grpSpPr>
          <p:pic>
            <p:nvPicPr>
              <p:cNvPr id="183" name="Image 182" descr="CROPSJ4103 J9 HT115 X63 V20.jpg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73" r="6791"/>
              <a:stretch/>
            </p:blipFill>
            <p:spPr>
              <a:xfrm>
                <a:off x="4543983" y="2423565"/>
                <a:ext cx="2238379" cy="526975"/>
              </a:xfrm>
              <a:prstGeom prst="rect">
                <a:avLst/>
              </a:prstGeom>
            </p:spPr>
          </p:pic>
          <p:sp>
            <p:nvSpPr>
              <p:cNvPr id="184" name="ZoneTexte 183"/>
              <p:cNvSpPr txBox="1"/>
              <p:nvPr/>
            </p:nvSpPr>
            <p:spPr>
              <a:xfrm>
                <a:off x="4544541" y="2424426"/>
                <a:ext cx="12103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881390">
                  <a:defRPr/>
                </a:pPr>
                <a:r>
                  <a:rPr lang="fr-FR" sz="800" kern="0" err="1" smtClean="0">
                    <a:solidFill>
                      <a:srgbClr val="FFFFFF"/>
                    </a:solidFill>
                    <a:latin typeface="Arial" charset="0"/>
                    <a:ea typeface="Arial" charset="0"/>
                    <a:cs typeface="Arial" charset="0"/>
                  </a:rPr>
                  <a:t>Fragmented</a:t>
                </a:r>
                <a:endParaRPr lang="fr-FR" sz="800" kern="0">
                  <a:solidFill>
                    <a:srgbClr val="FFFFFF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85" name="Connecteur droit 184"/>
              <p:cNvCxnSpPr/>
              <p:nvPr/>
            </p:nvCxnSpPr>
            <p:spPr>
              <a:xfrm flipV="1">
                <a:off x="4610449" y="2864158"/>
                <a:ext cx="254325" cy="635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0" name="Grouper 179"/>
            <p:cNvGrpSpPr/>
            <p:nvPr/>
          </p:nvGrpSpPr>
          <p:grpSpPr>
            <a:xfrm>
              <a:off x="496619" y="606745"/>
              <a:ext cx="2242384" cy="505460"/>
              <a:chOff x="4532598" y="676693"/>
              <a:chExt cx="2242384" cy="505460"/>
            </a:xfrm>
          </p:grpSpPr>
          <p:pic>
            <p:nvPicPr>
              <p:cNvPr id="181" name="Image 180" descr="CROP connected CROP MAX_22_02_2017_EN208xEN3742_D1_7-1.jpg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73" r="6791"/>
              <a:stretch/>
            </p:blipFill>
            <p:spPr>
              <a:xfrm>
                <a:off x="4532598" y="676693"/>
                <a:ext cx="2242384" cy="505460"/>
              </a:xfrm>
              <a:prstGeom prst="rect">
                <a:avLst/>
              </a:prstGeom>
            </p:spPr>
          </p:pic>
          <p:sp>
            <p:nvSpPr>
              <p:cNvPr id="182" name="ZoneTexte 181"/>
              <p:cNvSpPr txBox="1"/>
              <p:nvPr/>
            </p:nvSpPr>
            <p:spPr>
              <a:xfrm>
                <a:off x="4542521" y="685365"/>
                <a:ext cx="12103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881390">
                  <a:defRPr/>
                </a:pPr>
                <a:r>
                  <a:rPr lang="fr-FR" sz="800" kern="0" err="1" smtClean="0">
                    <a:solidFill>
                      <a:srgbClr val="FFFFFF"/>
                    </a:solidFill>
                    <a:latin typeface="Arial" charset="0"/>
                    <a:ea typeface="Arial" charset="0"/>
                    <a:cs typeface="Arial" charset="0"/>
                  </a:rPr>
                  <a:t>Tubular</a:t>
                </a:r>
                <a:endParaRPr lang="fr-FR" sz="800" kern="0">
                  <a:solidFill>
                    <a:srgbClr val="FFFFFF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sp>
        <p:nvSpPr>
          <p:cNvPr id="112" name="ZoneTexte 111"/>
          <p:cNvSpPr txBox="1"/>
          <p:nvPr/>
        </p:nvSpPr>
        <p:spPr>
          <a:xfrm>
            <a:off x="465873" y="1482580"/>
            <a:ext cx="56019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 smtClean="0">
                <a:latin typeface="Arial" charset="0"/>
                <a:ea typeface="Arial" charset="0"/>
                <a:cs typeface="Arial" charset="0"/>
              </a:rPr>
              <a:t>a	</a:t>
            </a:r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	 </a:t>
            </a:r>
            <a:r>
              <a:rPr lang="en-GB" sz="800" b="1" dirty="0" smtClean="0">
                <a:latin typeface="Arial" charset="0"/>
                <a:ea typeface="Arial" charset="0"/>
                <a:cs typeface="Arial" charset="0"/>
              </a:rPr>
              <a:t>       	          b				       c		          d	        </a:t>
            </a:r>
            <a:endParaRPr lang="en-GB" sz="800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46" name="Group 45"/>
          <p:cNvGrpSpPr>
            <a:grpSpLocks noChangeAspect="1"/>
          </p:cNvGrpSpPr>
          <p:nvPr/>
        </p:nvGrpSpPr>
        <p:grpSpPr>
          <a:xfrm>
            <a:off x="3909000" y="1734584"/>
            <a:ext cx="1924166" cy="902295"/>
            <a:chOff x="174572" y="565065"/>
            <a:chExt cx="3055028" cy="1432583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459" t="38939" r="9854" b="5694"/>
            <a:stretch/>
          </p:blipFill>
          <p:spPr>
            <a:xfrm>
              <a:off x="174572" y="566826"/>
              <a:ext cx="1410978" cy="1428524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785" r="16192" b="12000"/>
            <a:stretch/>
          </p:blipFill>
          <p:spPr>
            <a:xfrm rot="16200000">
              <a:off x="1647828" y="570123"/>
              <a:ext cx="1432583" cy="1422467"/>
            </a:xfrm>
            <a:prstGeom prst="rect">
              <a:avLst/>
            </a:prstGeom>
          </p:spPr>
        </p:pic>
        <p:grpSp>
          <p:nvGrpSpPr>
            <p:cNvPr id="49" name="Group 48"/>
            <p:cNvGrpSpPr>
              <a:grpSpLocks noChangeAspect="1"/>
            </p:cNvGrpSpPr>
            <p:nvPr/>
          </p:nvGrpSpPr>
          <p:grpSpPr>
            <a:xfrm>
              <a:off x="859379" y="572373"/>
              <a:ext cx="2370221" cy="342063"/>
              <a:chOff x="855202" y="572371"/>
              <a:chExt cx="2352884" cy="339560"/>
            </a:xfrm>
          </p:grpSpPr>
          <p:sp>
            <p:nvSpPr>
              <p:cNvPr id="58" name="ZoneTexte 70"/>
              <p:cNvSpPr txBox="1">
                <a:spLocks noChangeArrowheads="1"/>
              </p:cNvSpPr>
              <p:nvPr/>
            </p:nvSpPr>
            <p:spPr bwMode="auto">
              <a:xfrm>
                <a:off x="855202" y="572371"/>
                <a:ext cx="825214" cy="3395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r>
                  <a:rPr lang="fr-FR" sz="800" dirty="0" smtClean="0">
                    <a:solidFill>
                      <a:srgbClr val="FFFFFF"/>
                    </a:solidFill>
                    <a:latin typeface="Arial" charset="0"/>
                    <a:ea typeface="Arial" charset="0"/>
                    <a:cs typeface="Arial" charset="0"/>
                  </a:rPr>
                  <a:t>Day 13</a:t>
                </a:r>
                <a:endParaRPr lang="fr-FR" sz="800" dirty="0">
                  <a:solidFill>
                    <a:srgbClr val="FFFFFF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59" name="ZoneTexte 70"/>
              <p:cNvSpPr txBox="1">
                <a:spLocks noChangeArrowheads="1"/>
              </p:cNvSpPr>
              <p:nvPr/>
            </p:nvSpPr>
            <p:spPr bwMode="auto">
              <a:xfrm>
                <a:off x="2316863" y="572371"/>
                <a:ext cx="891223" cy="3395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r>
                  <a:rPr lang="fr-FR" sz="800" dirty="0" smtClean="0">
                    <a:solidFill>
                      <a:srgbClr val="FFFFFF"/>
                    </a:solidFill>
                    <a:latin typeface="Arial" charset="0"/>
                    <a:ea typeface="Arial" charset="0"/>
                    <a:cs typeface="Arial" charset="0"/>
                  </a:rPr>
                  <a:t>Day 13</a:t>
                </a:r>
                <a:endParaRPr lang="fr-FR" sz="800" dirty="0">
                  <a:solidFill>
                    <a:srgbClr val="FFFFFF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1331316" y="1949232"/>
              <a:ext cx="1686064" cy="4436"/>
              <a:chOff x="1344159" y="2954994"/>
              <a:chExt cx="1686064" cy="4436"/>
            </a:xfrm>
          </p:grpSpPr>
          <p:cxnSp>
            <p:nvCxnSpPr>
              <p:cNvPr id="56" name="Connecteur droit 166"/>
              <p:cNvCxnSpPr/>
              <p:nvPr/>
            </p:nvCxnSpPr>
            <p:spPr>
              <a:xfrm flipV="1">
                <a:off x="1344159" y="2954994"/>
                <a:ext cx="199635" cy="1354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necteur droit 166"/>
              <p:cNvCxnSpPr/>
              <p:nvPr/>
            </p:nvCxnSpPr>
            <p:spPr>
              <a:xfrm flipV="1">
                <a:off x="2830588" y="2958076"/>
                <a:ext cx="199635" cy="1354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" name="Rectangle 1"/>
          <p:cNvSpPr/>
          <p:nvPr/>
        </p:nvSpPr>
        <p:spPr>
          <a:xfrm>
            <a:off x="10259" y="3668236"/>
            <a:ext cx="671641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/>
                <a:ea typeface="Arial" charset="0"/>
                <a:cs typeface="Arial"/>
              </a:rPr>
              <a:t>Figure S2 </a:t>
            </a:r>
            <a:r>
              <a:rPr lang="en-US" sz="1000" b="1">
                <a:latin typeface="Arial"/>
                <a:cs typeface="Arial"/>
              </a:rPr>
              <a:t>Illustration </a:t>
            </a:r>
            <a:r>
              <a:rPr lang="en-US" sz="1000" b="1" smtClean="0">
                <a:latin typeface="Arial"/>
                <a:cs typeface="Arial"/>
              </a:rPr>
              <a:t>of muscle </a:t>
            </a:r>
            <a:r>
              <a:rPr lang="en-US" sz="1000" b="1" dirty="0">
                <a:latin typeface="Arial"/>
                <a:cs typeface="Arial"/>
              </a:rPr>
              <a:t>phenotypes observed with aging. </a:t>
            </a:r>
            <a:endParaRPr lang="fr-FR" sz="1000" dirty="0">
              <a:solidFill>
                <a:srgbClr val="FF0000"/>
              </a:solidFill>
              <a:latin typeface="Arial"/>
              <a:ea typeface="Arial" charset="0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6748814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12</TotalTime>
  <Words>22</Words>
  <Application>Microsoft Macintosh PowerPoint</Application>
  <PresentationFormat>Présentation à l'écran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eline</dc:creator>
  <cp:lastModifiedBy>Florence Solari</cp:lastModifiedBy>
  <cp:revision>1213</cp:revision>
  <cp:lastPrinted>2017-08-11T12:03:05Z</cp:lastPrinted>
  <dcterms:created xsi:type="dcterms:W3CDTF">2015-07-15T09:53:29Z</dcterms:created>
  <dcterms:modified xsi:type="dcterms:W3CDTF">2017-10-13T09:08:48Z</dcterms:modified>
</cp:coreProperties>
</file>